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7" r:id="rId2"/>
    <p:sldId id="272" r:id="rId3"/>
    <p:sldId id="274" r:id="rId4"/>
    <p:sldId id="275" r:id="rId5"/>
    <p:sldId id="276" r:id="rId6"/>
    <p:sldId id="277" r:id="rId7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 Davidson" userId="a779c1e4-d436-42de-ab48-3249bf694334" providerId="ADAL" clId="{2191B203-3D35-4417-81A4-194C8E490622}"/>
    <pc:docChg chg="custSel addSld delSld modSld">
      <pc:chgData name="Ben Davidson" userId="a779c1e4-d436-42de-ab48-3249bf694334" providerId="ADAL" clId="{2191B203-3D35-4417-81A4-194C8E490622}" dt="2023-05-10T12:11:10.063" v="302" actId="1076"/>
      <pc:docMkLst>
        <pc:docMk/>
      </pc:docMkLst>
      <pc:sldChg chg="addSp delSp modSp mod">
        <pc:chgData name="Ben Davidson" userId="a779c1e4-d436-42de-ab48-3249bf694334" providerId="ADAL" clId="{2191B203-3D35-4417-81A4-194C8E490622}" dt="2023-05-10T11:29:43.194" v="57" actId="1035"/>
        <pc:sldMkLst>
          <pc:docMk/>
          <pc:sldMk cId="198155822" sldId="267"/>
        </pc:sldMkLst>
        <pc:spChg chg="add mod">
          <ac:chgData name="Ben Davidson" userId="a779c1e4-d436-42de-ab48-3249bf694334" providerId="ADAL" clId="{2191B203-3D35-4417-81A4-194C8E490622}" dt="2023-05-10T11:29:43.194" v="57" actId="1035"/>
          <ac:spMkLst>
            <pc:docMk/>
            <pc:sldMk cId="198155822" sldId="267"/>
            <ac:spMk id="11" creationId="{559E0A60-0A1C-B77D-BA4B-09BFE6EC9513}"/>
          </ac:spMkLst>
        </pc:spChg>
        <pc:spChg chg="add mod">
          <ac:chgData name="Ben Davidson" userId="a779c1e4-d436-42de-ab48-3249bf694334" providerId="ADAL" clId="{2191B203-3D35-4417-81A4-194C8E490622}" dt="2023-05-10T11:29:43.194" v="57" actId="1035"/>
          <ac:spMkLst>
            <pc:docMk/>
            <pc:sldMk cId="198155822" sldId="267"/>
            <ac:spMk id="12" creationId="{83E01EEA-A5BF-8EC6-06DF-E4CF6856916A}"/>
          </ac:spMkLst>
        </pc:spChg>
        <pc:spChg chg="del">
          <ac:chgData name="Ben Davidson" userId="a779c1e4-d436-42de-ab48-3249bf694334" providerId="ADAL" clId="{2191B203-3D35-4417-81A4-194C8E490622}" dt="2023-05-10T11:29:26.575" v="39" actId="21"/>
          <ac:spMkLst>
            <pc:docMk/>
            <pc:sldMk cId="198155822" sldId="267"/>
            <ac:spMk id="15" creationId="{00000000-0000-0000-0000-000000000000}"/>
          </ac:spMkLst>
        </pc:spChg>
        <pc:spChg chg="del">
          <ac:chgData name="Ben Davidson" userId="a779c1e4-d436-42de-ab48-3249bf694334" providerId="ADAL" clId="{2191B203-3D35-4417-81A4-194C8E490622}" dt="2023-05-10T11:29:26.575" v="39" actId="21"/>
          <ac:spMkLst>
            <pc:docMk/>
            <pc:sldMk cId="198155822" sldId="267"/>
            <ac:spMk id="16" creationId="{00000000-0000-0000-0000-000000000000}"/>
          </ac:spMkLst>
        </pc:spChg>
        <pc:picChg chg="add mod">
          <ac:chgData name="Ben Davidson" userId="a779c1e4-d436-42de-ab48-3249bf694334" providerId="ADAL" clId="{2191B203-3D35-4417-81A4-194C8E490622}" dt="2023-05-10T11:29:43.194" v="57" actId="1035"/>
          <ac:picMkLst>
            <pc:docMk/>
            <pc:sldMk cId="198155822" sldId="267"/>
            <ac:picMk id="3" creationId="{A90228AF-9199-3EF0-A2DB-F3247F6D13BB}"/>
          </ac:picMkLst>
        </pc:picChg>
        <pc:picChg chg="del">
          <ac:chgData name="Ben Davidson" userId="a779c1e4-d436-42de-ab48-3249bf694334" providerId="ADAL" clId="{2191B203-3D35-4417-81A4-194C8E490622}" dt="2023-05-10T11:25:50.455" v="1" actId="478"/>
          <ac:picMkLst>
            <pc:docMk/>
            <pc:sldMk cId="198155822" sldId="267"/>
            <ac:picMk id="5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29:43.194" v="57" actId="1035"/>
          <ac:picMkLst>
            <pc:docMk/>
            <pc:sldMk cId="198155822" sldId="267"/>
            <ac:picMk id="6" creationId="{3CC8BE89-920B-4B73-1FF2-74EA1EC5C2EE}"/>
          </ac:picMkLst>
        </pc:picChg>
        <pc:picChg chg="del">
          <ac:chgData name="Ben Davidson" userId="a779c1e4-d436-42de-ab48-3249bf694334" providerId="ADAL" clId="{2191B203-3D35-4417-81A4-194C8E490622}" dt="2023-05-10T11:25:48.248" v="0" actId="478"/>
          <ac:picMkLst>
            <pc:docMk/>
            <pc:sldMk cId="198155822" sldId="267"/>
            <ac:picMk id="8" creationId="{00000000-0000-0000-0000-000000000000}"/>
          </ac:picMkLst>
        </pc:picChg>
        <pc:picChg chg="add del mod">
          <ac:chgData name="Ben Davidson" userId="a779c1e4-d436-42de-ab48-3249bf694334" providerId="ADAL" clId="{2191B203-3D35-4417-81A4-194C8E490622}" dt="2023-05-10T11:27:06.784" v="12" actId="478"/>
          <ac:picMkLst>
            <pc:docMk/>
            <pc:sldMk cId="198155822" sldId="267"/>
            <ac:picMk id="9" creationId="{90F529B6-5368-E0D9-F38C-80415423E0BA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57:07.114" v="181" actId="1036"/>
        <pc:sldMkLst>
          <pc:docMk/>
          <pc:sldMk cId="3761349374" sldId="268"/>
        </pc:sldMkLst>
        <pc:spChg chg="del mod">
          <ac:chgData name="Ben Davidson" userId="a779c1e4-d436-42de-ab48-3249bf694334" providerId="ADAL" clId="{2191B203-3D35-4417-81A4-194C8E490622}" dt="2023-05-10T11:56:59.172" v="140" actId="21"/>
          <ac:spMkLst>
            <pc:docMk/>
            <pc:sldMk cId="3761349374" sldId="268"/>
            <ac:spMk id="5" creationId="{00000000-0000-0000-0000-000000000000}"/>
          </ac:spMkLst>
        </pc:spChg>
        <pc:spChg chg="add mod">
          <ac:chgData name="Ben Davidson" userId="a779c1e4-d436-42de-ab48-3249bf694334" providerId="ADAL" clId="{2191B203-3D35-4417-81A4-194C8E490622}" dt="2023-05-10T11:57:07.114" v="181" actId="1036"/>
          <ac:spMkLst>
            <pc:docMk/>
            <pc:sldMk cId="3761349374" sldId="268"/>
            <ac:spMk id="7" creationId="{1A060636-A4E7-EB8B-839B-7973B907215E}"/>
          </ac:spMkLst>
        </pc:spChg>
        <pc:picChg chg="del">
          <ac:chgData name="Ben Davidson" userId="a779c1e4-d436-42de-ab48-3249bf694334" providerId="ADAL" clId="{2191B203-3D35-4417-81A4-194C8E490622}" dt="2023-05-10T11:55:21.006" v="133" actId="478"/>
          <ac:picMkLst>
            <pc:docMk/>
            <pc:sldMk cId="3761349374" sldId="268"/>
            <ac:picMk id="2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55:37.450" v="135" actId="931"/>
          <ac:picMkLst>
            <pc:docMk/>
            <pc:sldMk cId="3761349374" sldId="268"/>
            <ac:picMk id="6" creationId="{E316E487-1727-0290-D68E-A81F2B74CD08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58:42.973" v="201" actId="20577"/>
        <pc:sldMkLst>
          <pc:docMk/>
          <pc:sldMk cId="3611017591" sldId="269"/>
        </pc:sldMkLst>
        <pc:spChg chg="del mod">
          <ac:chgData name="Ben Davidson" userId="a779c1e4-d436-42de-ab48-3249bf694334" providerId="ADAL" clId="{2191B203-3D35-4417-81A4-194C8E490622}" dt="2023-05-10T11:58:29.420" v="193" actId="21"/>
          <ac:spMkLst>
            <pc:docMk/>
            <pc:sldMk cId="3611017591" sldId="269"/>
            <ac:spMk id="5" creationId="{00000000-0000-0000-0000-000000000000}"/>
          </ac:spMkLst>
        </pc:spChg>
        <pc:spChg chg="add mod">
          <ac:chgData name="Ben Davidson" userId="a779c1e4-d436-42de-ab48-3249bf694334" providerId="ADAL" clId="{2191B203-3D35-4417-81A4-194C8E490622}" dt="2023-05-10T11:58:42.973" v="201" actId="20577"/>
          <ac:spMkLst>
            <pc:docMk/>
            <pc:sldMk cId="3611017591" sldId="269"/>
            <ac:spMk id="7" creationId="{375660FC-26E8-6F9F-5276-43EB24A36E4F}"/>
          </ac:spMkLst>
        </pc:spChg>
        <pc:picChg chg="del">
          <ac:chgData name="Ben Davidson" userId="a779c1e4-d436-42de-ab48-3249bf694334" providerId="ADAL" clId="{2191B203-3D35-4417-81A4-194C8E490622}" dt="2023-05-10T11:58:09.591" v="190" actId="478"/>
          <ac:picMkLst>
            <pc:docMk/>
            <pc:sldMk cId="3611017591" sldId="269"/>
            <ac:picMk id="2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58:23.242" v="192" actId="931"/>
          <ac:picMkLst>
            <pc:docMk/>
            <pc:sldMk cId="3611017591" sldId="269"/>
            <ac:picMk id="6" creationId="{E1598C2C-5529-634D-5FE6-AC2A0E5CEF53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36:55.758" v="101" actId="1037"/>
        <pc:sldMkLst>
          <pc:docMk/>
          <pc:sldMk cId="669317452" sldId="272"/>
        </pc:sldMkLst>
        <pc:spChg chg="add mod">
          <ac:chgData name="Ben Davidson" userId="a779c1e4-d436-42de-ab48-3249bf694334" providerId="ADAL" clId="{2191B203-3D35-4417-81A4-194C8E490622}" dt="2023-05-10T11:35:53.255" v="100" actId="1035"/>
          <ac:spMkLst>
            <pc:docMk/>
            <pc:sldMk cId="669317452" sldId="272"/>
            <ac:spMk id="9" creationId="{66CE92C9-976A-8C7F-D876-AD796E61B4A1}"/>
          </ac:spMkLst>
        </pc:spChg>
        <pc:spChg chg="add mod">
          <ac:chgData name="Ben Davidson" userId="a779c1e4-d436-42de-ab48-3249bf694334" providerId="ADAL" clId="{2191B203-3D35-4417-81A4-194C8E490622}" dt="2023-05-10T11:36:55.758" v="101" actId="1037"/>
          <ac:spMkLst>
            <pc:docMk/>
            <pc:sldMk cId="669317452" sldId="272"/>
            <ac:spMk id="10" creationId="{5BFFA8A2-092F-CEF3-7CEF-8B54462D82D7}"/>
          </ac:spMkLst>
        </pc:spChg>
        <pc:spChg chg="del">
          <ac:chgData name="Ben Davidson" userId="a779c1e4-d436-42de-ab48-3249bf694334" providerId="ADAL" clId="{2191B203-3D35-4417-81A4-194C8E490622}" dt="2023-05-10T11:34:46.944" v="80" actId="21"/>
          <ac:spMkLst>
            <pc:docMk/>
            <pc:sldMk cId="669317452" sldId="272"/>
            <ac:spMk id="13" creationId="{00000000-0000-0000-0000-000000000000}"/>
          </ac:spMkLst>
        </pc:spChg>
        <pc:spChg chg="del">
          <ac:chgData name="Ben Davidson" userId="a779c1e4-d436-42de-ab48-3249bf694334" providerId="ADAL" clId="{2191B203-3D35-4417-81A4-194C8E490622}" dt="2023-05-10T11:34:46.944" v="80" actId="21"/>
          <ac:spMkLst>
            <pc:docMk/>
            <pc:sldMk cId="669317452" sldId="272"/>
            <ac:spMk id="14" creationId="{00000000-0000-0000-0000-000000000000}"/>
          </ac:spMkLst>
        </pc:spChg>
        <pc:picChg chg="del">
          <ac:chgData name="Ben Davidson" userId="a779c1e4-d436-42de-ab48-3249bf694334" providerId="ADAL" clId="{2191B203-3D35-4417-81A4-194C8E490622}" dt="2023-05-10T11:25:53.873" v="2" actId="478"/>
          <ac:picMkLst>
            <pc:docMk/>
            <pc:sldMk cId="669317452" sldId="272"/>
            <ac:picMk id="3" creationId="{00000000-0000-0000-0000-000000000000}"/>
          </ac:picMkLst>
        </pc:picChg>
        <pc:picChg chg="del">
          <ac:chgData name="Ben Davidson" userId="a779c1e4-d436-42de-ab48-3249bf694334" providerId="ADAL" clId="{2191B203-3D35-4417-81A4-194C8E490622}" dt="2023-05-10T11:25:55.718" v="3" actId="478"/>
          <ac:picMkLst>
            <pc:docMk/>
            <pc:sldMk cId="669317452" sldId="272"/>
            <ac:picMk id="4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35:53.255" v="100" actId="1035"/>
          <ac:picMkLst>
            <pc:docMk/>
            <pc:sldMk cId="669317452" sldId="272"/>
            <ac:picMk id="6" creationId="{429B04BB-F6FE-11BF-CE5D-F28D6401AE54}"/>
          </ac:picMkLst>
        </pc:picChg>
        <pc:picChg chg="add mod">
          <ac:chgData name="Ben Davidson" userId="a779c1e4-d436-42de-ab48-3249bf694334" providerId="ADAL" clId="{2191B203-3D35-4417-81A4-194C8E490622}" dt="2023-05-10T11:35:53.255" v="100" actId="1035"/>
          <ac:picMkLst>
            <pc:docMk/>
            <pc:sldMk cId="669317452" sldId="272"/>
            <ac:picMk id="8" creationId="{A0006353-31EF-F193-9920-7A116B746A18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40:32.781" v="132" actId="1035"/>
        <pc:sldMkLst>
          <pc:docMk/>
          <pc:sldMk cId="2068193662" sldId="274"/>
        </pc:sldMkLst>
        <pc:spChg chg="add mod">
          <ac:chgData name="Ben Davidson" userId="a779c1e4-d436-42de-ab48-3249bf694334" providerId="ADAL" clId="{2191B203-3D35-4417-81A4-194C8E490622}" dt="2023-05-10T11:40:32.781" v="132" actId="1035"/>
          <ac:spMkLst>
            <pc:docMk/>
            <pc:sldMk cId="2068193662" sldId="274"/>
            <ac:spMk id="8" creationId="{471BD3A1-7402-0FB9-354A-25A3ABEC3107}"/>
          </ac:spMkLst>
        </pc:spChg>
        <pc:spChg chg="add mod">
          <ac:chgData name="Ben Davidson" userId="a779c1e4-d436-42de-ab48-3249bf694334" providerId="ADAL" clId="{2191B203-3D35-4417-81A4-194C8E490622}" dt="2023-05-10T11:40:32.781" v="132" actId="1035"/>
          <ac:spMkLst>
            <pc:docMk/>
            <pc:sldMk cId="2068193662" sldId="274"/>
            <ac:spMk id="10" creationId="{05C77DE8-86D5-F0EF-229D-AC3B20BFE02D}"/>
          </ac:spMkLst>
        </pc:spChg>
        <pc:spChg chg="del">
          <ac:chgData name="Ben Davidson" userId="a779c1e4-d436-42de-ab48-3249bf694334" providerId="ADAL" clId="{2191B203-3D35-4417-81A4-194C8E490622}" dt="2023-05-10T11:39:52.049" v="113" actId="21"/>
          <ac:spMkLst>
            <pc:docMk/>
            <pc:sldMk cId="2068193662" sldId="274"/>
            <ac:spMk id="12" creationId="{00000000-0000-0000-0000-000000000000}"/>
          </ac:spMkLst>
        </pc:spChg>
        <pc:spChg chg="del">
          <ac:chgData name="Ben Davidson" userId="a779c1e4-d436-42de-ab48-3249bf694334" providerId="ADAL" clId="{2191B203-3D35-4417-81A4-194C8E490622}" dt="2023-05-10T11:39:52.049" v="113" actId="21"/>
          <ac:spMkLst>
            <pc:docMk/>
            <pc:sldMk cId="2068193662" sldId="274"/>
            <ac:spMk id="13" creationId="{00000000-0000-0000-0000-000000000000}"/>
          </ac:spMkLst>
        </pc:spChg>
        <pc:picChg chg="del">
          <ac:chgData name="Ben Davidson" userId="a779c1e4-d436-42de-ab48-3249bf694334" providerId="ADAL" clId="{2191B203-3D35-4417-81A4-194C8E490622}" dt="2023-05-10T11:26:01.054" v="5" actId="478"/>
          <ac:picMkLst>
            <pc:docMk/>
            <pc:sldMk cId="2068193662" sldId="274"/>
            <ac:picMk id="2" creationId="{00000000-0000-0000-0000-000000000000}"/>
          </ac:picMkLst>
        </pc:picChg>
        <pc:picChg chg="del">
          <ac:chgData name="Ben Davidson" userId="a779c1e4-d436-42de-ab48-3249bf694334" providerId="ADAL" clId="{2191B203-3D35-4417-81A4-194C8E490622}" dt="2023-05-10T11:25:58.965" v="4" actId="478"/>
          <ac:picMkLst>
            <pc:docMk/>
            <pc:sldMk cId="2068193662" sldId="274"/>
            <ac:picMk id="4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40:32.781" v="132" actId="1035"/>
          <ac:picMkLst>
            <pc:docMk/>
            <pc:sldMk cId="2068193662" sldId="274"/>
            <ac:picMk id="5" creationId="{9392E47B-D3D4-78B4-B392-117E0B770755}"/>
          </ac:picMkLst>
        </pc:picChg>
        <pc:picChg chg="add mod">
          <ac:chgData name="Ben Davidson" userId="a779c1e4-d436-42de-ab48-3249bf694334" providerId="ADAL" clId="{2191B203-3D35-4417-81A4-194C8E490622}" dt="2023-05-10T11:40:32.781" v="132" actId="1035"/>
          <ac:picMkLst>
            <pc:docMk/>
            <pc:sldMk cId="2068193662" sldId="274"/>
            <ac:picMk id="7" creationId="{58EC969B-EC77-4F68-AEB1-394D20CA43CA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57:56.309" v="189" actId="1076"/>
        <pc:sldMkLst>
          <pc:docMk/>
          <pc:sldMk cId="3683776117" sldId="275"/>
        </pc:sldMkLst>
        <pc:spChg chg="del mod">
          <ac:chgData name="Ben Davidson" userId="a779c1e4-d436-42de-ab48-3249bf694334" providerId="ADAL" clId="{2191B203-3D35-4417-81A4-194C8E490622}" dt="2023-05-10T11:57:51.269" v="187" actId="21"/>
          <ac:spMkLst>
            <pc:docMk/>
            <pc:sldMk cId="3683776117" sldId="275"/>
            <ac:spMk id="4" creationId="{00000000-0000-0000-0000-000000000000}"/>
          </ac:spMkLst>
        </pc:spChg>
        <pc:spChg chg="add mod">
          <ac:chgData name="Ben Davidson" userId="a779c1e4-d436-42de-ab48-3249bf694334" providerId="ADAL" clId="{2191B203-3D35-4417-81A4-194C8E490622}" dt="2023-05-10T11:57:56.309" v="189" actId="1076"/>
          <ac:spMkLst>
            <pc:docMk/>
            <pc:sldMk cId="3683776117" sldId="275"/>
            <ac:spMk id="7" creationId="{42B14597-105A-7B18-0625-73C7EF8DB823}"/>
          </ac:spMkLst>
        </pc:spChg>
        <pc:picChg chg="del">
          <ac:chgData name="Ben Davidson" userId="a779c1e4-d436-42de-ab48-3249bf694334" providerId="ADAL" clId="{2191B203-3D35-4417-81A4-194C8E490622}" dt="2023-05-10T11:57:17.399" v="182" actId="478"/>
          <ac:picMkLst>
            <pc:docMk/>
            <pc:sldMk cId="3683776117" sldId="275"/>
            <ac:picMk id="2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57:29.507" v="184" actId="931"/>
          <ac:picMkLst>
            <pc:docMk/>
            <pc:sldMk cId="3683776117" sldId="275"/>
            <ac:picMk id="6" creationId="{1466A760-814B-B25C-4C07-F506CBD57122}"/>
          </ac:picMkLst>
        </pc:picChg>
      </pc:sldChg>
      <pc:sldChg chg="delSp del mod">
        <pc:chgData name="Ben Davidson" userId="a779c1e4-d436-42de-ab48-3249bf694334" providerId="ADAL" clId="{2191B203-3D35-4417-81A4-194C8E490622}" dt="2023-05-10T11:59:09.347" v="203" actId="2696"/>
        <pc:sldMkLst>
          <pc:docMk/>
          <pc:sldMk cId="1625188007" sldId="276"/>
        </pc:sldMkLst>
        <pc:picChg chg="del">
          <ac:chgData name="Ben Davidson" userId="a779c1e4-d436-42de-ab48-3249bf694334" providerId="ADAL" clId="{2191B203-3D35-4417-81A4-194C8E490622}" dt="2023-05-10T11:59:03.700" v="202" actId="478"/>
          <ac:picMkLst>
            <pc:docMk/>
            <pc:sldMk cId="1625188007" sldId="276"/>
            <ac:picMk id="3" creationId="{00000000-0000-0000-0000-000000000000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1:59:50.050" v="213" actId="1076"/>
        <pc:sldMkLst>
          <pc:docMk/>
          <pc:sldMk cId="3181661344" sldId="277"/>
        </pc:sldMkLst>
        <pc:spChg chg="mod">
          <ac:chgData name="Ben Davidson" userId="a779c1e4-d436-42de-ab48-3249bf694334" providerId="ADAL" clId="{2191B203-3D35-4417-81A4-194C8E490622}" dt="2023-05-10T11:59:26.513" v="209" actId="20577"/>
          <ac:spMkLst>
            <pc:docMk/>
            <pc:sldMk cId="3181661344" sldId="277"/>
            <ac:spMk id="2" creationId="{00000000-0000-0000-0000-000000000000}"/>
          </ac:spMkLst>
        </pc:spChg>
        <pc:spChg chg="del mod">
          <ac:chgData name="Ben Davidson" userId="a779c1e4-d436-42de-ab48-3249bf694334" providerId="ADAL" clId="{2191B203-3D35-4417-81A4-194C8E490622}" dt="2023-05-10T11:59:46.198" v="211" actId="21"/>
          <ac:spMkLst>
            <pc:docMk/>
            <pc:sldMk cId="3181661344" sldId="277"/>
            <ac:spMk id="4" creationId="{00000000-0000-0000-0000-000000000000}"/>
          </ac:spMkLst>
        </pc:spChg>
        <pc:spChg chg="add mod">
          <ac:chgData name="Ben Davidson" userId="a779c1e4-d436-42de-ab48-3249bf694334" providerId="ADAL" clId="{2191B203-3D35-4417-81A4-194C8E490622}" dt="2023-05-10T11:59:50.050" v="213" actId="1076"/>
          <ac:spMkLst>
            <pc:docMk/>
            <pc:sldMk cId="3181661344" sldId="277"/>
            <ac:spMk id="7" creationId="{576FB552-B512-5D82-DDBF-0BABB75279D0}"/>
          </ac:spMkLst>
        </pc:spChg>
        <pc:picChg chg="del">
          <ac:chgData name="Ben Davidson" userId="a779c1e4-d436-42de-ab48-3249bf694334" providerId="ADAL" clId="{2191B203-3D35-4417-81A4-194C8E490622}" dt="2023-05-10T11:59:12.133" v="204" actId="478"/>
          <ac:picMkLst>
            <pc:docMk/>
            <pc:sldMk cId="3181661344" sldId="277"/>
            <ac:picMk id="3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1:59:38.355" v="210" actId="931"/>
          <ac:picMkLst>
            <pc:docMk/>
            <pc:sldMk cId="3181661344" sldId="277"/>
            <ac:picMk id="6" creationId="{922CB8E0-5ADC-B8EE-B483-1A297BE931F0}"/>
          </ac:picMkLst>
        </pc:picChg>
      </pc:sldChg>
      <pc:sldChg chg="addSp delSp modSp mod">
        <pc:chgData name="Ben Davidson" userId="a779c1e4-d436-42de-ab48-3249bf694334" providerId="ADAL" clId="{2191B203-3D35-4417-81A4-194C8E490622}" dt="2023-05-10T12:01:21.192" v="229" actId="1076"/>
        <pc:sldMkLst>
          <pc:docMk/>
          <pc:sldMk cId="2109460261" sldId="278"/>
        </pc:sldMkLst>
        <pc:spChg chg="mod">
          <ac:chgData name="Ben Davidson" userId="a779c1e4-d436-42de-ab48-3249bf694334" providerId="ADAL" clId="{2191B203-3D35-4417-81A4-194C8E490622}" dt="2023-05-10T12:00:17.099" v="217" actId="20577"/>
          <ac:spMkLst>
            <pc:docMk/>
            <pc:sldMk cId="2109460261" sldId="278"/>
            <ac:spMk id="2" creationId="{00000000-0000-0000-0000-000000000000}"/>
          </ac:spMkLst>
        </pc:spChg>
        <pc:spChg chg="del mod">
          <ac:chgData name="Ben Davidson" userId="a779c1e4-d436-42de-ab48-3249bf694334" providerId="ADAL" clId="{2191B203-3D35-4417-81A4-194C8E490622}" dt="2023-05-10T12:01:16.784" v="227" actId="21"/>
          <ac:spMkLst>
            <pc:docMk/>
            <pc:sldMk cId="2109460261" sldId="278"/>
            <ac:spMk id="4" creationId="{00000000-0000-0000-0000-000000000000}"/>
          </ac:spMkLst>
        </pc:spChg>
        <pc:spChg chg="add mod">
          <ac:chgData name="Ben Davidson" userId="a779c1e4-d436-42de-ab48-3249bf694334" providerId="ADAL" clId="{2191B203-3D35-4417-81A4-194C8E490622}" dt="2023-05-10T12:01:21.192" v="229" actId="1076"/>
          <ac:spMkLst>
            <pc:docMk/>
            <pc:sldMk cId="2109460261" sldId="278"/>
            <ac:spMk id="7" creationId="{EC8E0911-C76E-70CE-107E-C544682A2324}"/>
          </ac:spMkLst>
        </pc:spChg>
        <pc:picChg chg="del">
          <ac:chgData name="Ben Davidson" userId="a779c1e4-d436-42de-ab48-3249bf694334" providerId="ADAL" clId="{2191B203-3D35-4417-81A4-194C8E490622}" dt="2023-05-10T12:00:20.357" v="218" actId="478"/>
          <ac:picMkLst>
            <pc:docMk/>
            <pc:sldMk cId="2109460261" sldId="278"/>
            <ac:picMk id="3" creationId="{00000000-0000-0000-0000-000000000000}"/>
          </ac:picMkLst>
        </pc:picChg>
        <pc:picChg chg="add mod">
          <ac:chgData name="Ben Davidson" userId="a779c1e4-d436-42de-ab48-3249bf694334" providerId="ADAL" clId="{2191B203-3D35-4417-81A4-194C8E490622}" dt="2023-05-10T12:00:31.229" v="220" actId="931"/>
          <ac:picMkLst>
            <pc:docMk/>
            <pc:sldMk cId="2109460261" sldId="278"/>
            <ac:picMk id="6" creationId="{B388623E-EC00-3B7E-9947-BC204199FD20}"/>
          </ac:picMkLst>
        </pc:picChg>
      </pc:sldChg>
      <pc:sldChg chg="del">
        <pc:chgData name="Ben Davidson" userId="a779c1e4-d436-42de-ab48-3249bf694334" providerId="ADAL" clId="{2191B203-3D35-4417-81A4-194C8E490622}" dt="2023-05-10T12:00:00.169" v="214" actId="2696"/>
        <pc:sldMkLst>
          <pc:docMk/>
          <pc:sldMk cId="837261750" sldId="279"/>
        </pc:sldMkLst>
      </pc:sldChg>
      <pc:sldChg chg="addSp modSp new mod">
        <pc:chgData name="Ben Davidson" userId="a779c1e4-d436-42de-ab48-3249bf694334" providerId="ADAL" clId="{2191B203-3D35-4417-81A4-194C8E490622}" dt="2023-05-10T12:04:55.899" v="248" actId="20577"/>
        <pc:sldMkLst>
          <pc:docMk/>
          <pc:sldMk cId="3003134057" sldId="279"/>
        </pc:sldMkLst>
        <pc:spChg chg="add mod">
          <ac:chgData name="Ben Davidson" userId="a779c1e4-d436-42de-ab48-3249bf694334" providerId="ADAL" clId="{2191B203-3D35-4417-81A4-194C8E490622}" dt="2023-05-10T12:01:36.482" v="233" actId="20577"/>
          <ac:spMkLst>
            <pc:docMk/>
            <pc:sldMk cId="3003134057" sldId="279"/>
            <ac:spMk id="2" creationId="{0AF8A414-4673-01A9-FDFC-2C5724BA4560}"/>
          </ac:spMkLst>
        </pc:spChg>
        <pc:spChg chg="add mod">
          <ac:chgData name="Ben Davidson" userId="a779c1e4-d436-42de-ab48-3249bf694334" providerId="ADAL" clId="{2191B203-3D35-4417-81A4-194C8E490622}" dt="2023-05-10T12:04:55.899" v="248" actId="20577"/>
          <ac:spMkLst>
            <pc:docMk/>
            <pc:sldMk cId="3003134057" sldId="279"/>
            <ac:spMk id="5" creationId="{ACB7ADAE-1489-1CFE-147C-CA610279E272}"/>
          </ac:spMkLst>
        </pc:spChg>
        <pc:picChg chg="add mod">
          <ac:chgData name="Ben Davidson" userId="a779c1e4-d436-42de-ab48-3249bf694334" providerId="ADAL" clId="{2191B203-3D35-4417-81A4-194C8E490622}" dt="2023-05-10T12:04:36.258" v="234" actId="931"/>
          <ac:picMkLst>
            <pc:docMk/>
            <pc:sldMk cId="3003134057" sldId="279"/>
            <ac:picMk id="4" creationId="{FC47C055-43E6-49B4-C0B1-F091B77794AE}"/>
          </ac:picMkLst>
        </pc:picChg>
      </pc:sldChg>
      <pc:sldChg chg="del">
        <pc:chgData name="Ben Davidson" userId="a779c1e4-d436-42de-ab48-3249bf694334" providerId="ADAL" clId="{2191B203-3D35-4417-81A4-194C8E490622}" dt="2023-05-10T12:00:04.089" v="215" actId="2696"/>
        <pc:sldMkLst>
          <pc:docMk/>
          <pc:sldMk cId="1044323425" sldId="280"/>
        </pc:sldMkLst>
      </pc:sldChg>
      <pc:sldChg chg="addSp modSp new mod">
        <pc:chgData name="Ben Davidson" userId="a779c1e4-d436-42de-ab48-3249bf694334" providerId="ADAL" clId="{2191B203-3D35-4417-81A4-194C8E490622}" dt="2023-05-10T12:08:02.926" v="259" actId="20577"/>
        <pc:sldMkLst>
          <pc:docMk/>
          <pc:sldMk cId="1925414002" sldId="280"/>
        </pc:sldMkLst>
        <pc:spChg chg="add mod">
          <ac:chgData name="Ben Davidson" userId="a779c1e4-d436-42de-ab48-3249bf694334" providerId="ADAL" clId="{2191B203-3D35-4417-81A4-194C8E490622}" dt="2023-05-10T12:05:44.074" v="252" actId="20577"/>
          <ac:spMkLst>
            <pc:docMk/>
            <pc:sldMk cId="1925414002" sldId="280"/>
            <ac:spMk id="2" creationId="{D4AB8FC6-D398-5215-33A0-BE7D491E918F}"/>
          </ac:spMkLst>
        </pc:spChg>
        <pc:spChg chg="add mod">
          <ac:chgData name="Ben Davidson" userId="a779c1e4-d436-42de-ab48-3249bf694334" providerId="ADAL" clId="{2191B203-3D35-4417-81A4-194C8E490622}" dt="2023-05-10T12:08:02.926" v="259" actId="20577"/>
          <ac:spMkLst>
            <pc:docMk/>
            <pc:sldMk cId="1925414002" sldId="280"/>
            <ac:spMk id="5" creationId="{F9A97D93-A323-272A-56CE-368CB5D40966}"/>
          </ac:spMkLst>
        </pc:spChg>
        <pc:picChg chg="add mod">
          <ac:chgData name="Ben Davidson" userId="a779c1e4-d436-42de-ab48-3249bf694334" providerId="ADAL" clId="{2191B203-3D35-4417-81A4-194C8E490622}" dt="2023-05-10T12:07:47.738" v="253" actId="931"/>
          <ac:picMkLst>
            <pc:docMk/>
            <pc:sldMk cId="1925414002" sldId="280"/>
            <ac:picMk id="4" creationId="{4775246D-3BC1-E911-D254-03759B90EA35}"/>
          </ac:picMkLst>
        </pc:picChg>
      </pc:sldChg>
      <pc:sldChg chg="addSp modSp new mod">
        <pc:chgData name="Ben Davidson" userId="a779c1e4-d436-42de-ab48-3249bf694334" providerId="ADAL" clId="{2191B203-3D35-4417-81A4-194C8E490622}" dt="2023-05-10T12:11:10.063" v="302" actId="1076"/>
        <pc:sldMkLst>
          <pc:docMk/>
          <pc:sldMk cId="1710029523" sldId="281"/>
        </pc:sldMkLst>
        <pc:spChg chg="add mod">
          <ac:chgData name="Ben Davidson" userId="a779c1e4-d436-42de-ab48-3249bf694334" providerId="ADAL" clId="{2191B203-3D35-4417-81A4-194C8E490622}" dt="2023-05-10T12:08:22.576" v="263" actId="20577"/>
          <ac:spMkLst>
            <pc:docMk/>
            <pc:sldMk cId="1710029523" sldId="281"/>
            <ac:spMk id="2" creationId="{910B6074-6426-3AFD-371A-47DD1CE9B1E4}"/>
          </ac:spMkLst>
        </pc:spChg>
        <pc:spChg chg="add mod">
          <ac:chgData name="Ben Davidson" userId="a779c1e4-d436-42de-ab48-3249bf694334" providerId="ADAL" clId="{2191B203-3D35-4417-81A4-194C8E490622}" dt="2023-05-10T12:11:10.063" v="302" actId="1076"/>
          <ac:spMkLst>
            <pc:docMk/>
            <pc:sldMk cId="1710029523" sldId="281"/>
            <ac:spMk id="5" creationId="{26191085-0E4E-8FE9-B508-CC2305A56EAD}"/>
          </ac:spMkLst>
        </pc:spChg>
        <pc:picChg chg="add mod">
          <ac:chgData name="Ben Davidson" userId="a779c1e4-d436-42de-ab48-3249bf694334" providerId="ADAL" clId="{2191B203-3D35-4417-81A4-194C8E490622}" dt="2023-05-10T12:10:26.531" v="264" actId="931"/>
          <ac:picMkLst>
            <pc:docMk/>
            <pc:sldMk cId="1710029523" sldId="281"/>
            <ac:picMk id="4" creationId="{90EB9074-CC5D-D664-3C33-A5A16A0481A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D41B5B-D8FC-4552-BBB2-CC70E1BBF788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A4B93D-7FBF-48A4-BD0A-F6B12F287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20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A4B93D-7FBF-48A4-BD0A-F6B12F2874F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450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31307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58969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7223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53596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62874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68832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90177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7555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95269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5714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28855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B4DFA-C864-4CCD-B468-2EC3E2899D9E}" type="datetimeFigureOut">
              <a:rPr lang="nb-NO" smtClean="0"/>
              <a:t>24.08.2023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9EAA5-79A3-45C5-9C2E-1E905E3C249E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9675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12" y="908720"/>
            <a:ext cx="8105775" cy="4772025"/>
          </a:xfrm>
          <a:prstGeom prst="rect">
            <a:avLst/>
          </a:prstGeom>
        </p:spPr>
      </p:pic>
      <p:sp>
        <p:nvSpPr>
          <p:cNvPr id="8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4283968" y="2790677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003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155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B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764704"/>
            <a:ext cx="8096250" cy="4762500"/>
          </a:xfrm>
          <a:prstGeom prst="rect">
            <a:avLst/>
          </a:prstGeom>
        </p:spPr>
      </p:pic>
      <p:sp>
        <p:nvSpPr>
          <p:cNvPr id="11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4427984" y="2636912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007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317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C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12" y="764704"/>
            <a:ext cx="8105775" cy="4772025"/>
          </a:xfrm>
          <a:prstGeom prst="rect">
            <a:avLst/>
          </a:prstGeom>
        </p:spPr>
      </p:pic>
      <p:sp>
        <p:nvSpPr>
          <p:cNvPr id="12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6804248" y="1998589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023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193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D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12" y="764704"/>
            <a:ext cx="8105775" cy="4772025"/>
          </a:xfrm>
          <a:prstGeom prst="rect">
            <a:avLst/>
          </a:prstGeom>
        </p:spPr>
      </p:pic>
      <p:sp>
        <p:nvSpPr>
          <p:cNvPr id="4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6876256" y="2060848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5231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875" y="836712"/>
            <a:ext cx="8096250" cy="4762500"/>
          </a:xfrm>
          <a:prstGeom prst="rect">
            <a:avLst/>
          </a:prstGeom>
        </p:spPr>
      </p:pic>
      <p:sp>
        <p:nvSpPr>
          <p:cNvPr id="4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4716016" y="2132856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278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2017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44624"/>
            <a:ext cx="31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-F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875" y="1047750"/>
            <a:ext cx="8096250" cy="4762500"/>
          </a:xfrm>
          <a:prstGeom prst="rect">
            <a:avLst/>
          </a:prstGeom>
        </p:spPr>
      </p:pic>
      <p:sp>
        <p:nvSpPr>
          <p:cNvPr id="4" name="TextBox 20">
            <a:extLst>
              <a:ext uri="{FF2B5EF4-FFF2-40B4-BE49-F238E27FC236}">
                <a16:creationId xmlns:a16="http://schemas.microsoft.com/office/drawing/2014/main" id="{559E0A60-0A1C-B77D-BA4B-09BFE6EC9513}"/>
              </a:ext>
            </a:extLst>
          </p:cNvPr>
          <p:cNvSpPr txBox="1"/>
          <p:nvPr/>
        </p:nvSpPr>
        <p:spPr>
          <a:xfrm>
            <a:off x="3995936" y="2348880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=0.259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4425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75</TotalTime>
  <Words>25</Words>
  <Application>Microsoft Office PowerPoint</Application>
  <PresentationFormat>On-screen Show (4:3)</PresentationFormat>
  <Paragraphs>1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ikshospital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 McFadden</dc:creator>
  <cp:lastModifiedBy>Ben Davidson</cp:lastModifiedBy>
  <cp:revision>118</cp:revision>
  <dcterms:created xsi:type="dcterms:W3CDTF">2019-08-29T08:45:38Z</dcterms:created>
  <dcterms:modified xsi:type="dcterms:W3CDTF">2023-08-24T11:40:18Z</dcterms:modified>
</cp:coreProperties>
</file>